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70" d="100"/>
          <a:sy n="70" d="100"/>
        </p:scale>
        <p:origin x="525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5C1837-2C81-BB80-C126-B6008EB84A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5D9BD0D-D2C6-B812-557F-825183AD33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BF42398-1B75-A791-59FF-A822E28AC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DAFCE8F-57DA-FF25-4A2E-BA658DF4B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BDA593A-C996-C87A-751F-4E802BAB4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3034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185B03-CD0C-FDC8-D87A-C5DDD4D983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57BA7D3-329C-15EB-855A-A0D960711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137F134-8861-89C8-4598-263B476CB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26326D5-45EA-BEEC-A672-39DC5EB2A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2A77658-1C52-55EB-492E-9EFCDD780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319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74A5106-E7CE-6407-3920-C9C800DB38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1FB45F0-0E30-317C-86F7-0B29E00247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F5CE6F1-A749-9687-CB19-19B1BA129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06203B4-B02B-B373-DABE-8AD48442A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800A618-D331-C355-7829-9EF7D8CA9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8909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546F2F-712A-1C57-EAF7-E942C4902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621985F-9312-BEEB-8C84-5F8470BCA8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0952117-F1C9-13B7-EB6F-DD5C10D48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76B5F42-F994-EEF2-5023-43416D9EF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3020D65-B8D2-10C1-678D-8C2F6FAB4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8214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82B415-BF81-B122-84F4-7294AF8AA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E9D032A-E9DB-C9D2-5BD1-8AA9EFEB1E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5CDB97A-7B46-BB67-0060-76C7EB653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34B67E-4D8E-7782-A577-19F7D4BD5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2E6883-2EE0-F4D6-D38C-C53B3E3AE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0226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903F003-7F07-2765-996F-4983F9F414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A880C86-0DCA-6600-5BCB-ED47BB42F6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F237AFF-82A0-1C4A-72AB-B43955D823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7E94849-E1D8-ABF1-DE57-24694FE78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A08F99B-B1FD-B81E-1CC5-DEA3D6024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B8625CB-F4E7-BD28-6CD7-1BFC70729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2315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E1ADF1-FC41-E1E0-0310-C72038BA2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979B853-2C7A-86A3-D770-5F3BCB576C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11D2FED-AEC8-20F5-B3D9-7DDA6EDBA2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5D07FC6-FD67-339B-89A3-26F89F6290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C188FDA-3C61-321E-FF31-9FA7391CA3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B5D9662-DEF9-D29E-F90F-C348819DF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CDF8F45-A294-A9EA-C061-E6902EEB5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A32B435-43CF-71D0-987D-9ED19214D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2640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7287DE-31AA-BF43-5D64-C60CFC7E3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3F4A17F-3FFE-7216-E677-8064B48A9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74F6B0B-436E-AC11-DBBA-CEF5B8940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7FDFBBE-C72F-7891-8937-55B32A94B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2048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C620F02A-D7FF-DD27-3C74-436A64325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2F24DBA-BA5C-45D4-2AE8-3A6F87346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2FC0EB5-F80B-798F-AAD6-F52A5286E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5625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B9B19B8-BA34-978F-7B11-AF5B6F1D3E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032A2BD-F3F9-18A7-0B53-47D70E4F4D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C7C8DF4-EAAA-BC5F-0FF1-AFA4320EC0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F9A288F-DECD-85AF-9C45-06F670DB4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5F8FEFA-5C71-2008-E3C5-68454B489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CA0B168-CFC4-2872-4614-914400148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0243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844F65-CE4D-6528-CE41-03D3F1367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4FD0458-EEEF-9B53-CAB3-78EE8C930D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21EAF18-C9A4-ECE0-059D-23CB1C2B1A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0067E15-74E3-16C0-883D-877107328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A70290E-AD93-F02B-6452-DEF728B16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0D4BEF1-30C5-71BB-63C0-B6BF1946F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7911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B32C445-612A-F3F2-45EB-AC969B1AA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403F81E-E4F9-D436-1DF6-09060D476B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5AB061A-B427-B618-24D3-E1FF6922D9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135A96-AD43-4DDF-8C43-BA4374AFBF70}" type="datetimeFigureOut">
              <a:rPr lang="es-ES" smtClean="0"/>
              <a:pPr/>
              <a:t>31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77FE4BC-2B49-114D-47B3-F7A2DD202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A0DCBA6-8779-4FB9-8717-9CE28233F6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790010-6E99-4EDB-A68C-01474E4451BC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2950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hyperlink" Target="http://rna.tbi.univie.ac.at/cgi-bin/RNAWebSuite/RNAfold.cgi" TargetMode="External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50690D5-65DA-363D-423E-8F340640EF2C}"/>
              </a:ext>
            </a:extLst>
          </p:cNvPr>
          <p:cNvSpPr txBox="1"/>
          <p:nvPr/>
        </p:nvSpPr>
        <p:spPr>
          <a:xfrm>
            <a:off x="1255960" y="3738098"/>
            <a:ext cx="589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44" name="43 Grupo"/>
          <p:cNvGrpSpPr/>
          <p:nvPr/>
        </p:nvGrpSpPr>
        <p:grpSpPr>
          <a:xfrm>
            <a:off x="1802665" y="3584424"/>
            <a:ext cx="6778482" cy="1562656"/>
            <a:chOff x="2130211" y="3126071"/>
            <a:chExt cx="6667500" cy="1503431"/>
          </a:xfrm>
        </p:grpSpPr>
        <p:sp>
          <p:nvSpPr>
            <p:cNvPr id="41" name="35 CuadroTexto"/>
            <p:cNvSpPr txBox="1"/>
            <p:nvPr/>
          </p:nvSpPr>
          <p:spPr>
            <a:xfrm>
              <a:off x="4333142" y="4070266"/>
              <a:ext cx="823217" cy="26660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/>
                <a:t>miR827</a:t>
              </a:r>
            </a:p>
          </p:txBody>
        </p:sp>
        <p:sp>
          <p:nvSpPr>
            <p:cNvPr id="42" name="34 Forma libre"/>
            <p:cNvSpPr/>
            <p:nvPr/>
          </p:nvSpPr>
          <p:spPr>
            <a:xfrm flipH="1" flipV="1">
              <a:off x="3820283" y="3994189"/>
              <a:ext cx="1884900" cy="56099"/>
            </a:xfrm>
            <a:custGeom>
              <a:avLst/>
              <a:gdLst>
                <a:gd name="connsiteX0" fmla="*/ 35305 w 35305"/>
                <a:gd name="connsiteY0" fmla="*/ 0 h 1037968"/>
                <a:gd name="connsiteX1" fmla="*/ 0 w 35305"/>
                <a:gd name="connsiteY1" fmla="*/ 1037968 h 1037968"/>
                <a:gd name="connsiteX2" fmla="*/ 0 w 35305"/>
                <a:gd name="connsiteY2" fmla="*/ 1037968 h 10379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305" h="1037968">
                  <a:moveTo>
                    <a:pt x="35305" y="0"/>
                  </a:moveTo>
                  <a:lnTo>
                    <a:pt x="0" y="1037968"/>
                  </a:lnTo>
                  <a:lnTo>
                    <a:pt x="0" y="1037968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3" name="42 Imagen" descr="estructura secundària MIR827 20 nt extended.png"/>
            <p:cNvPicPr>
              <a:picLocks noChangeAspect="1"/>
            </p:cNvPicPr>
            <p:nvPr/>
          </p:nvPicPr>
          <p:blipFill>
            <a:blip r:embed="rId2" cstate="print"/>
            <a:srcRect l="37996" r="39455"/>
            <a:stretch>
              <a:fillRect/>
            </a:stretch>
          </p:blipFill>
          <p:spPr>
            <a:xfrm rot="16200000" flipH="1">
              <a:off x="4712245" y="544037"/>
              <a:ext cx="1503431" cy="6667500"/>
            </a:xfrm>
            <a:prstGeom prst="rect">
              <a:avLst/>
            </a:prstGeom>
          </p:spPr>
        </p:pic>
      </p:grpSp>
      <p:grpSp>
        <p:nvGrpSpPr>
          <p:cNvPr id="7" name="Grupo 6">
            <a:extLst>
              <a:ext uri="{FF2B5EF4-FFF2-40B4-BE49-F238E27FC236}">
                <a16:creationId xmlns:a16="http://schemas.microsoft.com/office/drawing/2014/main" id="{AC2081B3-7E53-63FF-206B-55AE9CB9B0CE}"/>
              </a:ext>
            </a:extLst>
          </p:cNvPr>
          <p:cNvGrpSpPr/>
          <p:nvPr/>
        </p:nvGrpSpPr>
        <p:grpSpPr>
          <a:xfrm>
            <a:off x="1033045" y="395790"/>
            <a:ext cx="9653156" cy="2906972"/>
            <a:chOff x="1033045" y="395790"/>
            <a:chExt cx="9653156" cy="2906972"/>
          </a:xfrm>
        </p:grpSpPr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60D89920-A572-D541-A994-8332D565DF8D}"/>
                </a:ext>
              </a:extLst>
            </p:cNvPr>
            <p:cNvGrpSpPr/>
            <p:nvPr/>
          </p:nvGrpSpPr>
          <p:grpSpPr>
            <a:xfrm>
              <a:off x="1753545" y="634624"/>
              <a:ext cx="8932656" cy="2668138"/>
              <a:chOff x="551186" y="1916399"/>
              <a:chExt cx="8765367" cy="2406385"/>
            </a:xfrm>
          </p:grpSpPr>
          <p:sp>
            <p:nvSpPr>
              <p:cNvPr id="61" name="16 CuadroTexto"/>
              <p:cNvSpPr txBox="1"/>
              <p:nvPr/>
            </p:nvSpPr>
            <p:spPr>
              <a:xfrm>
                <a:off x="1179837" y="1925027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2" name="17 CuadroTexto"/>
              <p:cNvSpPr txBox="1"/>
              <p:nvPr/>
            </p:nvSpPr>
            <p:spPr>
              <a:xfrm>
                <a:off x="3411897" y="1916399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s-ES_trad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Δ</a:t>
                </a:r>
                <a:r>
                  <a:rPr lang="es-ES_trad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18 CuadroTexto"/>
              <p:cNvSpPr txBox="1"/>
              <p:nvPr/>
            </p:nvSpPr>
            <p:spPr>
              <a:xfrm>
                <a:off x="2259769" y="1934851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s-ES_trad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8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19 CuadroTexto"/>
              <p:cNvSpPr txBox="1"/>
              <p:nvPr/>
            </p:nvSpPr>
            <p:spPr>
              <a:xfrm>
                <a:off x="7732377" y="1953004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2</a:t>
                </a:r>
              </a:p>
            </p:txBody>
          </p:sp>
          <p:sp>
            <p:nvSpPr>
              <p:cNvPr id="65" name="20 CuadroTexto"/>
              <p:cNvSpPr txBox="1"/>
              <p:nvPr/>
            </p:nvSpPr>
            <p:spPr>
              <a:xfrm>
                <a:off x="4991210" y="1934851"/>
                <a:ext cx="662607" cy="222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s-ES_trad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8 +7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21 CuadroTexto"/>
              <p:cNvSpPr txBox="1"/>
              <p:nvPr/>
            </p:nvSpPr>
            <p:spPr>
              <a:xfrm>
                <a:off x="6543637" y="1934851"/>
                <a:ext cx="3966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22 CuadroTexto"/>
              <p:cNvSpPr txBox="1"/>
              <p:nvPr/>
            </p:nvSpPr>
            <p:spPr>
              <a:xfrm>
                <a:off x="8812497" y="1953004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Δ2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1" name="28 Grupo"/>
              <p:cNvGrpSpPr/>
              <p:nvPr/>
            </p:nvGrpSpPr>
            <p:grpSpPr>
              <a:xfrm>
                <a:off x="4492017" y="2034183"/>
                <a:ext cx="1811038" cy="1597750"/>
                <a:chOff x="3735747" y="3313083"/>
                <a:chExt cx="1811038" cy="1597750"/>
              </a:xfrm>
            </p:grpSpPr>
            <p:pic>
              <p:nvPicPr>
                <p:cNvPr id="72" name="26 Imagen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62" r="-1" b="13280"/>
                <a:stretch/>
              </p:blipFill>
              <p:spPr>
                <a:xfrm>
                  <a:off x="3735747" y="3313083"/>
                  <a:ext cx="1811038" cy="1584176"/>
                </a:xfrm>
                <a:prstGeom prst="rect">
                  <a:avLst/>
                </a:prstGeom>
              </p:spPr>
            </p:pic>
            <p:sp>
              <p:nvSpPr>
                <p:cNvPr id="73" name="27 Rectángulo"/>
                <p:cNvSpPr/>
                <p:nvPr/>
              </p:nvSpPr>
              <p:spPr>
                <a:xfrm>
                  <a:off x="3837962" y="4865114"/>
                  <a:ext cx="446006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5" name="Agrupa 84"/>
              <p:cNvGrpSpPr/>
              <p:nvPr/>
            </p:nvGrpSpPr>
            <p:grpSpPr>
              <a:xfrm>
                <a:off x="1179835" y="2179280"/>
                <a:ext cx="535383" cy="2124000"/>
                <a:chOff x="1189361" y="2746285"/>
                <a:chExt cx="576026" cy="2728212"/>
              </a:xfrm>
            </p:grpSpPr>
            <p:pic>
              <p:nvPicPr>
                <p:cNvPr id="68" name="3 Imagen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167" r="41591"/>
                <a:stretch/>
              </p:blipFill>
              <p:spPr>
                <a:xfrm>
                  <a:off x="1189361" y="2746285"/>
                  <a:ext cx="497697" cy="2728212"/>
                </a:xfrm>
                <a:prstGeom prst="rect">
                  <a:avLst/>
                </a:prstGeom>
              </p:spPr>
            </p:pic>
            <p:sp>
              <p:nvSpPr>
                <p:cNvPr id="77" name="34 Forma libre"/>
                <p:cNvSpPr/>
                <p:nvPr/>
              </p:nvSpPr>
              <p:spPr>
                <a:xfrm>
                  <a:off x="1499738" y="2783773"/>
                  <a:ext cx="35305" cy="1037968"/>
                </a:xfrm>
                <a:custGeom>
                  <a:avLst/>
                  <a:gdLst>
                    <a:gd name="connsiteX0" fmla="*/ 35305 w 35305"/>
                    <a:gd name="connsiteY0" fmla="*/ 0 h 1037968"/>
                    <a:gd name="connsiteX1" fmla="*/ 0 w 35305"/>
                    <a:gd name="connsiteY1" fmla="*/ 1037968 h 1037968"/>
                    <a:gd name="connsiteX2" fmla="*/ 0 w 35305"/>
                    <a:gd name="connsiteY2" fmla="*/ 1037968 h 103796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35305" h="1037968">
                      <a:moveTo>
                        <a:pt x="35305" y="0"/>
                      </a:moveTo>
                      <a:lnTo>
                        <a:pt x="0" y="1037968"/>
                      </a:lnTo>
                      <a:lnTo>
                        <a:pt x="0" y="1037968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8" name="35 CuadroTexto"/>
                <p:cNvSpPr txBox="1"/>
                <p:nvPr/>
              </p:nvSpPr>
              <p:spPr>
                <a:xfrm rot="16200000">
                  <a:off x="1147821" y="3207524"/>
                  <a:ext cx="953662" cy="28147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US" sz="1100" b="1" dirty="0"/>
                    <a:t>miR827</a:t>
                  </a:r>
                </a:p>
              </p:txBody>
            </p:sp>
          </p:grpSp>
          <p:sp>
            <p:nvSpPr>
              <p:cNvPr id="79" name="37 Forma libre"/>
              <p:cNvSpPr/>
              <p:nvPr/>
            </p:nvSpPr>
            <p:spPr>
              <a:xfrm>
                <a:off x="5356113" y="2434821"/>
                <a:ext cx="987414" cy="354330"/>
              </a:xfrm>
              <a:custGeom>
                <a:avLst/>
                <a:gdLst>
                  <a:gd name="connsiteX0" fmla="*/ 0 w 987414"/>
                  <a:gd name="connsiteY0" fmla="*/ 0 h 354330"/>
                  <a:gd name="connsiteX1" fmla="*/ 118110 w 987414"/>
                  <a:gd name="connsiteY1" fmla="*/ 19050 h 354330"/>
                  <a:gd name="connsiteX2" fmla="*/ 247650 w 987414"/>
                  <a:gd name="connsiteY2" fmla="*/ 80010 h 354330"/>
                  <a:gd name="connsiteX3" fmla="*/ 335280 w 987414"/>
                  <a:gd name="connsiteY3" fmla="*/ 186690 h 354330"/>
                  <a:gd name="connsiteX4" fmla="*/ 388620 w 987414"/>
                  <a:gd name="connsiteY4" fmla="*/ 179070 h 354330"/>
                  <a:gd name="connsiteX5" fmla="*/ 483870 w 987414"/>
                  <a:gd name="connsiteY5" fmla="*/ 152400 h 354330"/>
                  <a:gd name="connsiteX6" fmla="*/ 605790 w 987414"/>
                  <a:gd name="connsiteY6" fmla="*/ 118110 h 354330"/>
                  <a:gd name="connsiteX7" fmla="*/ 716280 w 987414"/>
                  <a:gd name="connsiteY7" fmla="*/ 87630 h 354330"/>
                  <a:gd name="connsiteX8" fmla="*/ 807720 w 987414"/>
                  <a:gd name="connsiteY8" fmla="*/ 34290 h 354330"/>
                  <a:gd name="connsiteX9" fmla="*/ 933450 w 987414"/>
                  <a:gd name="connsiteY9" fmla="*/ 68580 h 354330"/>
                  <a:gd name="connsiteX10" fmla="*/ 971550 w 987414"/>
                  <a:gd name="connsiteY10" fmla="*/ 148590 h 354330"/>
                  <a:gd name="connsiteX11" fmla="*/ 986790 w 987414"/>
                  <a:gd name="connsiteY11" fmla="*/ 255270 h 354330"/>
                  <a:gd name="connsiteX12" fmla="*/ 952500 w 987414"/>
                  <a:gd name="connsiteY12" fmla="*/ 316230 h 354330"/>
                  <a:gd name="connsiteX13" fmla="*/ 887730 w 987414"/>
                  <a:gd name="connsiteY13" fmla="*/ 346710 h 354330"/>
                  <a:gd name="connsiteX14" fmla="*/ 792480 w 987414"/>
                  <a:gd name="connsiteY14" fmla="*/ 339090 h 354330"/>
                  <a:gd name="connsiteX15" fmla="*/ 712470 w 987414"/>
                  <a:gd name="connsiteY15" fmla="*/ 354330 h 354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987414" h="354330">
                    <a:moveTo>
                      <a:pt x="0" y="0"/>
                    </a:moveTo>
                    <a:cubicBezTo>
                      <a:pt x="38417" y="2857"/>
                      <a:pt x="76835" y="5715"/>
                      <a:pt x="118110" y="19050"/>
                    </a:cubicBezTo>
                    <a:cubicBezTo>
                      <a:pt x="159385" y="32385"/>
                      <a:pt x="211455" y="52070"/>
                      <a:pt x="247650" y="80010"/>
                    </a:cubicBezTo>
                    <a:cubicBezTo>
                      <a:pt x="283845" y="107950"/>
                      <a:pt x="311785" y="170180"/>
                      <a:pt x="335280" y="186690"/>
                    </a:cubicBezTo>
                    <a:cubicBezTo>
                      <a:pt x="358775" y="203200"/>
                      <a:pt x="363855" y="184785"/>
                      <a:pt x="388620" y="179070"/>
                    </a:cubicBezTo>
                    <a:cubicBezTo>
                      <a:pt x="413385" y="173355"/>
                      <a:pt x="483870" y="152400"/>
                      <a:pt x="483870" y="152400"/>
                    </a:cubicBezTo>
                    <a:lnTo>
                      <a:pt x="605790" y="118110"/>
                    </a:lnTo>
                    <a:cubicBezTo>
                      <a:pt x="644525" y="107315"/>
                      <a:pt x="682625" y="101600"/>
                      <a:pt x="716280" y="87630"/>
                    </a:cubicBezTo>
                    <a:cubicBezTo>
                      <a:pt x="749935" y="73660"/>
                      <a:pt x="771525" y="37465"/>
                      <a:pt x="807720" y="34290"/>
                    </a:cubicBezTo>
                    <a:cubicBezTo>
                      <a:pt x="843915" y="31115"/>
                      <a:pt x="906145" y="49530"/>
                      <a:pt x="933450" y="68580"/>
                    </a:cubicBezTo>
                    <a:cubicBezTo>
                      <a:pt x="960755" y="87630"/>
                      <a:pt x="962660" y="117475"/>
                      <a:pt x="971550" y="148590"/>
                    </a:cubicBezTo>
                    <a:cubicBezTo>
                      <a:pt x="980440" y="179705"/>
                      <a:pt x="989965" y="227330"/>
                      <a:pt x="986790" y="255270"/>
                    </a:cubicBezTo>
                    <a:cubicBezTo>
                      <a:pt x="983615" y="283210"/>
                      <a:pt x="969010" y="300990"/>
                      <a:pt x="952500" y="316230"/>
                    </a:cubicBezTo>
                    <a:cubicBezTo>
                      <a:pt x="935990" y="331470"/>
                      <a:pt x="914400" y="342900"/>
                      <a:pt x="887730" y="346710"/>
                    </a:cubicBezTo>
                    <a:cubicBezTo>
                      <a:pt x="861060" y="350520"/>
                      <a:pt x="821690" y="337820"/>
                      <a:pt x="792480" y="339090"/>
                    </a:cubicBezTo>
                    <a:cubicBezTo>
                      <a:pt x="763270" y="340360"/>
                      <a:pt x="737870" y="347345"/>
                      <a:pt x="712470" y="35433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87" name="Agrupa 86"/>
              <p:cNvGrpSpPr/>
              <p:nvPr/>
            </p:nvGrpSpPr>
            <p:grpSpPr>
              <a:xfrm>
                <a:off x="3351671" y="2210861"/>
                <a:ext cx="595795" cy="2052000"/>
                <a:chOff x="3361196" y="2777866"/>
                <a:chExt cx="595795" cy="2455062"/>
              </a:xfrm>
            </p:grpSpPr>
            <p:pic>
              <p:nvPicPr>
                <p:cNvPr id="70" name="7 Imagen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991" r="36674"/>
                <a:stretch/>
              </p:blipFill>
              <p:spPr>
                <a:xfrm>
                  <a:off x="3361196" y="2784656"/>
                  <a:ext cx="595795" cy="2448272"/>
                </a:xfrm>
                <a:prstGeom prst="rect">
                  <a:avLst/>
                </a:prstGeom>
              </p:spPr>
            </p:pic>
            <p:sp>
              <p:nvSpPr>
                <p:cNvPr id="80" name="39 Forma libre"/>
                <p:cNvSpPr/>
                <p:nvPr/>
              </p:nvSpPr>
              <p:spPr>
                <a:xfrm>
                  <a:off x="3822022" y="2777866"/>
                  <a:ext cx="72762" cy="520574"/>
                </a:xfrm>
                <a:custGeom>
                  <a:avLst/>
                  <a:gdLst>
                    <a:gd name="connsiteX0" fmla="*/ 0 w 72762"/>
                    <a:gd name="connsiteY0" fmla="*/ 0 h 520574"/>
                    <a:gd name="connsiteX1" fmla="*/ 67901 w 72762"/>
                    <a:gd name="connsiteY1" fmla="*/ 63374 h 520574"/>
                    <a:gd name="connsiteX2" fmla="*/ 63374 w 72762"/>
                    <a:gd name="connsiteY2" fmla="*/ 153909 h 520574"/>
                    <a:gd name="connsiteX3" fmla="*/ 31687 w 72762"/>
                    <a:gd name="connsiteY3" fmla="*/ 194649 h 520574"/>
                    <a:gd name="connsiteX4" fmla="*/ 27161 w 72762"/>
                    <a:gd name="connsiteY4" fmla="*/ 461727 h 520574"/>
                    <a:gd name="connsiteX5" fmla="*/ 54321 w 72762"/>
                    <a:gd name="connsiteY5" fmla="*/ 520574 h 52057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72762" h="520574">
                      <a:moveTo>
                        <a:pt x="0" y="0"/>
                      </a:moveTo>
                      <a:cubicBezTo>
                        <a:pt x="28669" y="18861"/>
                        <a:pt x="57339" y="37723"/>
                        <a:pt x="67901" y="63374"/>
                      </a:cubicBezTo>
                      <a:cubicBezTo>
                        <a:pt x="78463" y="89025"/>
                        <a:pt x="69410" y="132030"/>
                        <a:pt x="63374" y="153909"/>
                      </a:cubicBezTo>
                      <a:cubicBezTo>
                        <a:pt x="57338" y="175788"/>
                        <a:pt x="37722" y="143346"/>
                        <a:pt x="31687" y="194649"/>
                      </a:cubicBezTo>
                      <a:cubicBezTo>
                        <a:pt x="25652" y="245952"/>
                        <a:pt x="23389" y="407406"/>
                        <a:pt x="27161" y="461727"/>
                      </a:cubicBezTo>
                      <a:cubicBezTo>
                        <a:pt x="30933" y="516048"/>
                        <a:pt x="42627" y="518311"/>
                        <a:pt x="54321" y="520574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6" name="Agrupa 85"/>
              <p:cNvGrpSpPr/>
              <p:nvPr/>
            </p:nvGrpSpPr>
            <p:grpSpPr>
              <a:xfrm>
                <a:off x="2221048" y="2204849"/>
                <a:ext cx="430435" cy="725822"/>
                <a:chOff x="2230573" y="2771854"/>
                <a:chExt cx="430435" cy="725822"/>
              </a:xfrm>
            </p:grpSpPr>
            <p:pic>
              <p:nvPicPr>
                <p:cNvPr id="69" name="4 Imagen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701" r="21665"/>
                <a:stretch/>
              </p:blipFill>
              <p:spPr>
                <a:xfrm>
                  <a:off x="2269294" y="2812579"/>
                  <a:ext cx="360642" cy="648248"/>
                </a:xfrm>
                <a:prstGeom prst="rect">
                  <a:avLst/>
                </a:prstGeom>
              </p:spPr>
            </p:pic>
            <p:sp>
              <p:nvSpPr>
                <p:cNvPr id="81" name="40 Forma libre"/>
                <p:cNvSpPr/>
                <p:nvPr/>
              </p:nvSpPr>
              <p:spPr>
                <a:xfrm>
                  <a:off x="2230573" y="2771854"/>
                  <a:ext cx="430435" cy="725822"/>
                </a:xfrm>
                <a:custGeom>
                  <a:avLst/>
                  <a:gdLst>
                    <a:gd name="connsiteX0" fmla="*/ 311398 w 430435"/>
                    <a:gd name="connsiteY0" fmla="*/ 0 h 725822"/>
                    <a:gd name="connsiteX1" fmla="*/ 373577 w 430435"/>
                    <a:gd name="connsiteY1" fmla="*/ 36576 h 725822"/>
                    <a:gd name="connsiteX2" fmla="*/ 421126 w 430435"/>
                    <a:gd name="connsiteY2" fmla="*/ 91440 h 725822"/>
                    <a:gd name="connsiteX3" fmla="*/ 424783 w 430435"/>
                    <a:gd name="connsiteY3" fmla="*/ 201168 h 725822"/>
                    <a:gd name="connsiteX4" fmla="*/ 358947 w 430435"/>
                    <a:gd name="connsiteY4" fmla="*/ 285293 h 725822"/>
                    <a:gd name="connsiteX5" fmla="*/ 322371 w 430435"/>
                    <a:gd name="connsiteY5" fmla="*/ 343815 h 725822"/>
                    <a:gd name="connsiteX6" fmla="*/ 230931 w 430435"/>
                    <a:gd name="connsiteY6" fmla="*/ 574244 h 725822"/>
                    <a:gd name="connsiteX7" fmla="*/ 223615 w 430435"/>
                    <a:gd name="connsiteY7" fmla="*/ 647396 h 725822"/>
                    <a:gd name="connsiteX8" fmla="*/ 161436 w 430435"/>
                    <a:gd name="connsiteY8" fmla="*/ 716890 h 725822"/>
                    <a:gd name="connsiteX9" fmla="*/ 91942 w 430435"/>
                    <a:gd name="connsiteY9" fmla="*/ 720548 h 725822"/>
                    <a:gd name="connsiteX10" fmla="*/ 22447 w 430435"/>
                    <a:gd name="connsiteY10" fmla="*/ 676656 h 725822"/>
                    <a:gd name="connsiteX11" fmla="*/ 502 w 430435"/>
                    <a:gd name="connsiteY11" fmla="*/ 577901 h 725822"/>
                    <a:gd name="connsiteX12" fmla="*/ 11475 w 430435"/>
                    <a:gd name="connsiteY12" fmla="*/ 526695 h 725822"/>
                    <a:gd name="connsiteX13" fmla="*/ 59023 w 430435"/>
                    <a:gd name="connsiteY13" fmla="*/ 515722 h 725822"/>
                    <a:gd name="connsiteX14" fmla="*/ 84627 w 430435"/>
                    <a:gd name="connsiteY14" fmla="*/ 471831 h 7258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</a:cxnLst>
                  <a:rect l="l" t="t" r="r" b="b"/>
                  <a:pathLst>
                    <a:path w="430435" h="725822">
                      <a:moveTo>
                        <a:pt x="311398" y="0"/>
                      </a:moveTo>
                      <a:cubicBezTo>
                        <a:pt x="333343" y="10668"/>
                        <a:pt x="355289" y="21336"/>
                        <a:pt x="373577" y="36576"/>
                      </a:cubicBezTo>
                      <a:cubicBezTo>
                        <a:pt x="391865" y="51816"/>
                        <a:pt x="412592" y="64008"/>
                        <a:pt x="421126" y="91440"/>
                      </a:cubicBezTo>
                      <a:cubicBezTo>
                        <a:pt x="429660" y="118872"/>
                        <a:pt x="435146" y="168859"/>
                        <a:pt x="424783" y="201168"/>
                      </a:cubicBezTo>
                      <a:cubicBezTo>
                        <a:pt x="414420" y="233477"/>
                        <a:pt x="376016" y="261518"/>
                        <a:pt x="358947" y="285293"/>
                      </a:cubicBezTo>
                      <a:cubicBezTo>
                        <a:pt x="341878" y="309068"/>
                        <a:pt x="343707" y="295657"/>
                        <a:pt x="322371" y="343815"/>
                      </a:cubicBezTo>
                      <a:cubicBezTo>
                        <a:pt x="301035" y="391973"/>
                        <a:pt x="247390" y="523647"/>
                        <a:pt x="230931" y="574244"/>
                      </a:cubicBezTo>
                      <a:cubicBezTo>
                        <a:pt x="214472" y="624841"/>
                        <a:pt x="235197" y="623622"/>
                        <a:pt x="223615" y="647396"/>
                      </a:cubicBezTo>
                      <a:cubicBezTo>
                        <a:pt x="212032" y="671170"/>
                        <a:pt x="183381" y="704698"/>
                        <a:pt x="161436" y="716890"/>
                      </a:cubicBezTo>
                      <a:cubicBezTo>
                        <a:pt x="139491" y="729082"/>
                        <a:pt x="115107" y="727254"/>
                        <a:pt x="91942" y="720548"/>
                      </a:cubicBezTo>
                      <a:cubicBezTo>
                        <a:pt x="68777" y="713842"/>
                        <a:pt x="37687" y="700430"/>
                        <a:pt x="22447" y="676656"/>
                      </a:cubicBezTo>
                      <a:cubicBezTo>
                        <a:pt x="7207" y="652882"/>
                        <a:pt x="2331" y="602895"/>
                        <a:pt x="502" y="577901"/>
                      </a:cubicBezTo>
                      <a:cubicBezTo>
                        <a:pt x="-1327" y="552908"/>
                        <a:pt x="1722" y="537058"/>
                        <a:pt x="11475" y="526695"/>
                      </a:cubicBezTo>
                      <a:cubicBezTo>
                        <a:pt x="21228" y="516332"/>
                        <a:pt x="46831" y="524866"/>
                        <a:pt x="59023" y="515722"/>
                      </a:cubicBezTo>
                      <a:cubicBezTo>
                        <a:pt x="71215" y="506578"/>
                        <a:pt x="77921" y="489204"/>
                        <a:pt x="84627" y="471831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8" name="Agrupa 87"/>
              <p:cNvGrpSpPr/>
              <p:nvPr/>
            </p:nvGrpSpPr>
            <p:grpSpPr>
              <a:xfrm>
                <a:off x="6440909" y="2179386"/>
                <a:ext cx="545408" cy="2124000"/>
                <a:chOff x="6450434" y="2746391"/>
                <a:chExt cx="545408" cy="2846577"/>
              </a:xfrm>
            </p:grpSpPr>
            <p:pic>
              <p:nvPicPr>
                <p:cNvPr id="74" name="29 Imagen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991" r="41849"/>
                <a:stretch/>
              </p:blipFill>
              <p:spPr>
                <a:xfrm>
                  <a:off x="6450434" y="2746391"/>
                  <a:ext cx="545408" cy="2846577"/>
                </a:xfrm>
                <a:prstGeom prst="rect">
                  <a:avLst/>
                </a:prstGeom>
              </p:spPr>
            </p:pic>
            <p:sp>
              <p:nvSpPr>
                <p:cNvPr id="82" name="41 Forma libre"/>
                <p:cNvSpPr/>
                <p:nvPr/>
              </p:nvSpPr>
              <p:spPr>
                <a:xfrm>
                  <a:off x="6835993" y="2786485"/>
                  <a:ext cx="32919" cy="1075334"/>
                </a:xfrm>
                <a:custGeom>
                  <a:avLst/>
                  <a:gdLst>
                    <a:gd name="connsiteX0" fmla="*/ 32919 w 32919"/>
                    <a:gd name="connsiteY0" fmla="*/ 0 h 1075334"/>
                    <a:gd name="connsiteX1" fmla="*/ 0 w 32919"/>
                    <a:gd name="connsiteY1" fmla="*/ 1075334 h 10753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2919" h="1075334">
                      <a:moveTo>
                        <a:pt x="32919" y="0"/>
                      </a:moveTo>
                      <a:lnTo>
                        <a:pt x="0" y="1075334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9" name="Agrupa 88"/>
              <p:cNvGrpSpPr/>
              <p:nvPr/>
            </p:nvGrpSpPr>
            <p:grpSpPr>
              <a:xfrm>
                <a:off x="7673296" y="2198784"/>
                <a:ext cx="622217" cy="2124000"/>
                <a:chOff x="7682821" y="2765789"/>
                <a:chExt cx="622217" cy="2699252"/>
              </a:xfrm>
            </p:grpSpPr>
            <p:pic>
              <p:nvPicPr>
                <p:cNvPr id="75" name="30 Imagen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040" r="39909"/>
                <a:stretch/>
              </p:blipFill>
              <p:spPr>
                <a:xfrm>
                  <a:off x="7682821" y="2765789"/>
                  <a:ext cx="622217" cy="2699252"/>
                </a:xfrm>
                <a:prstGeom prst="rect">
                  <a:avLst/>
                </a:prstGeom>
              </p:spPr>
            </p:pic>
            <p:sp>
              <p:nvSpPr>
                <p:cNvPr id="83" name="42 Forma libre"/>
                <p:cNvSpPr/>
                <p:nvPr/>
              </p:nvSpPr>
              <p:spPr>
                <a:xfrm>
                  <a:off x="8026288" y="2835456"/>
                  <a:ext cx="19050" cy="1009650"/>
                </a:xfrm>
                <a:custGeom>
                  <a:avLst/>
                  <a:gdLst>
                    <a:gd name="connsiteX0" fmla="*/ 0 w 19050"/>
                    <a:gd name="connsiteY0" fmla="*/ 0 h 1009650"/>
                    <a:gd name="connsiteX1" fmla="*/ 19050 w 19050"/>
                    <a:gd name="connsiteY1" fmla="*/ 1009650 h 10096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9050" h="1009650">
                      <a:moveTo>
                        <a:pt x="0" y="0"/>
                      </a:moveTo>
                      <a:lnTo>
                        <a:pt x="19050" y="100965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90" name="Agrupa 89"/>
              <p:cNvGrpSpPr/>
              <p:nvPr/>
            </p:nvGrpSpPr>
            <p:grpSpPr>
              <a:xfrm>
                <a:off x="8740489" y="2179280"/>
                <a:ext cx="488635" cy="2124000"/>
                <a:chOff x="8750014" y="2746285"/>
                <a:chExt cx="488635" cy="2829694"/>
              </a:xfrm>
            </p:grpSpPr>
            <p:pic>
              <p:nvPicPr>
                <p:cNvPr id="76" name="31 Imagen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914" r="41059"/>
                <a:stretch/>
              </p:blipFill>
              <p:spPr>
                <a:xfrm>
                  <a:off x="8750014" y="2746285"/>
                  <a:ext cx="488635" cy="2829694"/>
                </a:xfrm>
                <a:prstGeom prst="rect">
                  <a:avLst/>
                </a:prstGeom>
              </p:spPr>
            </p:pic>
            <p:sp>
              <p:nvSpPr>
                <p:cNvPr id="84" name="43 Forma libre"/>
                <p:cNvSpPr/>
                <p:nvPr/>
              </p:nvSpPr>
              <p:spPr>
                <a:xfrm>
                  <a:off x="9118488" y="2781481"/>
                  <a:ext cx="44450" cy="987425"/>
                </a:xfrm>
                <a:custGeom>
                  <a:avLst/>
                  <a:gdLst>
                    <a:gd name="connsiteX0" fmla="*/ 44450 w 44450"/>
                    <a:gd name="connsiteY0" fmla="*/ 0 h 987425"/>
                    <a:gd name="connsiteX1" fmla="*/ 0 w 44450"/>
                    <a:gd name="connsiteY1" fmla="*/ 987425 h 9874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4450" h="987425">
                      <a:moveTo>
                        <a:pt x="44450" y="0"/>
                      </a:moveTo>
                      <a:lnTo>
                        <a:pt x="0" y="987425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91" name="90 Imagen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05" t="82571" r="68603" b="8029"/>
              <a:stretch/>
            </p:blipFill>
            <p:spPr>
              <a:xfrm>
                <a:off x="598228" y="3849445"/>
                <a:ext cx="630497" cy="273215"/>
              </a:xfrm>
              <a:prstGeom prst="rect">
                <a:avLst/>
              </a:prstGeom>
            </p:spPr>
          </p:pic>
          <p:sp>
            <p:nvSpPr>
              <p:cNvPr id="92" name="16 CuadroTexto"/>
              <p:cNvSpPr txBox="1"/>
              <p:nvPr/>
            </p:nvSpPr>
            <p:spPr>
              <a:xfrm>
                <a:off x="551186" y="3601103"/>
                <a:ext cx="76326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probability</a:t>
                </a:r>
              </a:p>
            </p:txBody>
          </p:sp>
        </p:grp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8DD839C4-B596-C1AE-2779-C5B286338ADC}"/>
                </a:ext>
              </a:extLst>
            </p:cNvPr>
            <p:cNvSpPr txBox="1"/>
            <p:nvPr/>
          </p:nvSpPr>
          <p:spPr>
            <a:xfrm>
              <a:off x="1033045" y="629718"/>
              <a:ext cx="5898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ECCC65D3-EFB6-DE65-37EB-B861B06AFB17}"/>
                </a:ext>
              </a:extLst>
            </p:cNvPr>
            <p:cNvSpPr txBox="1"/>
            <p:nvPr/>
          </p:nvSpPr>
          <p:spPr>
            <a:xfrm>
              <a:off x="3371001" y="395790"/>
              <a:ext cx="7165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/>
                <a:t>Line 23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A40EC6AA-DEA4-099D-AD2E-A79E50D68E36}"/>
                </a:ext>
              </a:extLst>
            </p:cNvPr>
            <p:cNvSpPr txBox="1"/>
            <p:nvPr/>
          </p:nvSpPr>
          <p:spPr>
            <a:xfrm>
              <a:off x="6212017" y="445830"/>
              <a:ext cx="7165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/>
                <a:t>Line 38</a:t>
              </a:r>
            </a:p>
          </p:txBody>
        </p:sp>
      </p:grpSp>
      <p:sp>
        <p:nvSpPr>
          <p:cNvPr id="9" name="CuadroTexto 8">
            <a:extLst>
              <a:ext uri="{FF2B5EF4-FFF2-40B4-BE49-F238E27FC236}">
                <a16:creationId xmlns:a16="http://schemas.microsoft.com/office/drawing/2014/main" id="{7E7D6162-854C-57F7-EE66-C27789D06CC9}"/>
              </a:ext>
            </a:extLst>
          </p:cNvPr>
          <p:cNvSpPr txBox="1"/>
          <p:nvPr/>
        </p:nvSpPr>
        <p:spPr>
          <a:xfrm>
            <a:off x="1269245" y="5111082"/>
            <a:ext cx="10188054" cy="144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4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redicted secondary structure of the miR827 precursor, wild-type (WT) and mutant alleles generated by CRISPR/Cas9 mutagenesis. The fold-back structure of the mutated miR827 precursor was obtained using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Afold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b Server (</a:t>
            </a:r>
            <a:r>
              <a:rPr lang="en-US" sz="12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11"/>
              </a:rPr>
              <a:t>http://rna.tbi.univie.ac.at/cgi-bin/RNAWebSuite/RNAfold.cgi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location of the mature miR827 in the precursor structure is indicated with a black line. Colors indicate the base pairing probability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edicted precursor structure of the wild-type and mutant miR827 precursors based on the nucleotide sequence currently annotated in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Base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ecursor structure predicted for the wild-type miR827 precursor upon extending its nucleotide sequence from the genomic region surrounding the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827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ocus (20 nucleotides upstream/downstream).</a:t>
            </a:r>
            <a:endParaRPr lang="es-E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82006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164</Words>
  <Application>Microsoft Office PowerPoint</Application>
  <PresentationFormat>Panorámica</PresentationFormat>
  <Paragraphs>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lanca San Segundo de los Mozos</dc:creator>
  <cp:lastModifiedBy>Blanca San Segundo de los Mozos</cp:lastModifiedBy>
  <cp:revision>14</cp:revision>
  <cp:lastPrinted>2024-05-20T16:53:32Z</cp:lastPrinted>
  <dcterms:created xsi:type="dcterms:W3CDTF">2024-05-13T07:55:33Z</dcterms:created>
  <dcterms:modified xsi:type="dcterms:W3CDTF">2024-05-31T17:12:15Z</dcterms:modified>
</cp:coreProperties>
</file>